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10"/>
    <p:restoredTop sz="94694"/>
  </p:normalViewPr>
  <p:slideViewPr>
    <p:cSldViewPr snapToGrid="0" snapToObjects="1">
      <p:cViewPr varScale="1">
        <p:scale>
          <a:sx n="114" d="100"/>
          <a:sy n="114" d="100"/>
        </p:scale>
        <p:origin x="472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F8AA49B-BB99-3740-A109-B666163895F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9D2F99D-DA91-9A45-9622-00F650D78E7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A9F2796-A194-3648-8EB2-F3A5CB1AC5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D76352-9715-224D-B8E4-3B17D0B78E74}" type="datetimeFigureOut">
              <a:rPr lang="en-US" smtClean="0"/>
              <a:t>7/9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473F933-543E-0C4D-9358-67DDF6E471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F6D0354-D29D-2A42-9E52-C2C595AAA6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1905C-6E26-5542-A619-63DA52DD25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95097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DEE6E79-37E1-B041-A6AB-98041F3B37A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2DE4BB2-593A-4F45-BB9F-FF6F3C1133C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F71E01E-52CE-024A-83B2-0E7B720D9A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D76352-9715-224D-B8E4-3B17D0B78E74}" type="datetimeFigureOut">
              <a:rPr lang="en-US" smtClean="0"/>
              <a:t>7/9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272E322-9295-5F45-97B4-8C4A0BA313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71E25AB-695F-7D41-A06F-1285EEE61C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1905C-6E26-5542-A619-63DA52DD25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08481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00EE4B8-9CB5-B145-B212-3369E9A4950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661AF3B-D352-7B46-BA4C-D385CD783CD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16DAB95-BDA7-894A-B104-AEBE04A743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D76352-9715-224D-B8E4-3B17D0B78E74}" type="datetimeFigureOut">
              <a:rPr lang="en-US" smtClean="0"/>
              <a:t>7/9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3BC67D8-D17B-0647-8554-6865FC8853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782EFA3-DF7A-1447-9E81-6E069ECE19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1905C-6E26-5542-A619-63DA52DD25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90377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FB23D03-18DE-4A40-89D8-5909BE3915B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CE47DFB-4ABC-544F-B7C6-6C4C3FA2F8F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29A1E68-D5BE-8F49-8B2A-B4A5D9C5F2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D76352-9715-224D-B8E4-3B17D0B78E74}" type="datetimeFigureOut">
              <a:rPr lang="en-US" smtClean="0"/>
              <a:t>7/9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FEC79A2-516B-A948-8268-9895F4CDB2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E92B2C0-15F5-1742-B83D-20F74A863E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1905C-6E26-5542-A619-63DA52DD25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23585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62D4B58-B803-6B4E-8BDE-FE10D41C73B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E294BAA-A108-404F-9DBE-DC0B33977E9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95CFA55-D032-D84A-BA7D-577B13E648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D76352-9715-224D-B8E4-3B17D0B78E74}" type="datetimeFigureOut">
              <a:rPr lang="en-US" smtClean="0"/>
              <a:t>7/9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629FC1E-61F4-5149-8B8B-966151E38E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FECB741-F3A1-644E-8D2F-6C811B8461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1905C-6E26-5542-A619-63DA52DD25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27657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EFB2DB4-BF58-A147-B1A6-75E5E2AA36B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759F758-9C09-CB47-AF66-C151E83A4E4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71E3636-36B8-1B43-B29E-A87879BE376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F41B6FE-30F2-044F-9BC0-E6DEEADF2C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D76352-9715-224D-B8E4-3B17D0B78E74}" type="datetimeFigureOut">
              <a:rPr lang="en-US" smtClean="0"/>
              <a:t>7/9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1C308BD-6154-4049-B6E0-2CEBBF6ACD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6E110BC-1F85-9445-8908-6EFC7E1CD3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1905C-6E26-5542-A619-63DA52DD25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56254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6693484-0E0B-CB4A-995F-E0833B32AAD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525043B-03DF-444D-9834-EED24EFA0A0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A66FCB0-8AF7-704E-A110-1D6D76FCADF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74E6C52-B358-FD4B-8588-859FBF80165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AFBE772-6745-0F40-B8B3-535129D2CF0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9F359EC-CEF0-4F41-BB70-206E383976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D76352-9715-224D-B8E4-3B17D0B78E74}" type="datetimeFigureOut">
              <a:rPr lang="en-US" smtClean="0"/>
              <a:t>7/9/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E6DEB15-CFA8-0F45-8505-5B1EF3D404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8D2D21A-AD57-E046-A85F-FD4EBE06ED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1905C-6E26-5542-A619-63DA52DD25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93238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48A5DB4-BAE4-6F46-8AA3-ECC6024B4DC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6E30EE5-C410-F54F-8123-66A9874E25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D76352-9715-224D-B8E4-3B17D0B78E74}" type="datetimeFigureOut">
              <a:rPr lang="en-US" smtClean="0"/>
              <a:t>7/9/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EBA0ABE-DA5D-4547-A2CF-E9F1189FB7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2B7CFFD-759A-6D40-8710-0570F5C2BB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1905C-6E26-5542-A619-63DA52DD25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82848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9CED697-4E70-1741-AD5B-E33AD2DCF3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D76352-9715-224D-B8E4-3B17D0B78E74}" type="datetimeFigureOut">
              <a:rPr lang="en-US" smtClean="0"/>
              <a:t>7/9/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8980D07-370E-6E4E-AEA4-A059954304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320AEA1-BDAF-2F48-B4CC-0833AA33FB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1905C-6E26-5542-A619-63DA52DD25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03678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3348823-E391-FA44-81DC-9F103DBD93F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D2023D6-2BB4-4B44-9465-E236494C9CA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C6E984A-923D-354A-A62B-8B19BECFC3E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2A580DD-6E97-CB43-ABC7-DA4C2F8BE1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D76352-9715-224D-B8E4-3B17D0B78E74}" type="datetimeFigureOut">
              <a:rPr lang="en-US" smtClean="0"/>
              <a:t>7/9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CD5E48E-7938-FA41-9788-5DA770B1EF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915C559-AA1F-0D41-85BD-4A38D69B56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1905C-6E26-5542-A619-63DA52DD25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12914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6BC799-9BF3-524C-BDC8-E7E0F146E57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4A9171E-E8E3-E243-89D3-E10D21F7951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57EEAF3-010F-1247-928D-F8039902700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6B77B17-26CD-594E-AF72-44BDA79446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D76352-9715-224D-B8E4-3B17D0B78E74}" type="datetimeFigureOut">
              <a:rPr lang="en-US" smtClean="0"/>
              <a:t>7/9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97C3214-5B5A-A148-9A4F-3225D10391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457CBD3-6498-EB4A-830F-ADBFCCEFDB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1905C-6E26-5542-A619-63DA52DD25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36979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C801070-E767-AB46-A760-5EC6260F7EF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4512DA9-2CDB-A542-A932-10F40C727EB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16EA7DC-0DF4-A443-9866-9C076060CE5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D76352-9715-224D-B8E4-3B17D0B78E74}" type="datetimeFigureOut">
              <a:rPr lang="en-US" smtClean="0"/>
              <a:t>7/9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E37E22D-7720-CA4C-99A5-3C0F5D0219C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F674A9A-12EE-DA47-B40A-64E7A966FED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91905C-6E26-5542-A619-63DA52DD25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89259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Content Placeholder 4">
            <a:extLst>
              <a:ext uri="{FF2B5EF4-FFF2-40B4-BE49-F238E27FC236}">
                <a16:creationId xmlns:a16="http://schemas.microsoft.com/office/drawing/2014/main" id="{019E3A0C-BA7D-8B40-9633-5D20DAC99E5D}"/>
              </a:ext>
            </a:extLst>
          </p:cNvPr>
          <p:cNvGraphicFramePr>
            <a:graphicFrameLocks noGrp="1"/>
          </p:cNvGraphicFramePr>
          <p:nvPr>
            <p:ph idx="1"/>
          </p:nvPr>
        </p:nvGraphicFramePr>
        <p:xfrm>
          <a:off x="4577660" y="1825623"/>
          <a:ext cx="3036679" cy="4351342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736539">
                  <a:extLst>
                    <a:ext uri="{9D8B030D-6E8A-4147-A177-3AD203B41FA5}">
                      <a16:colId xmlns:a16="http://schemas.microsoft.com/office/drawing/2014/main" val="2009547698"/>
                    </a:ext>
                  </a:extLst>
                </a:gridCol>
                <a:gridCol w="582579">
                  <a:extLst>
                    <a:ext uri="{9D8B030D-6E8A-4147-A177-3AD203B41FA5}">
                      <a16:colId xmlns:a16="http://schemas.microsoft.com/office/drawing/2014/main" val="2428356950"/>
                    </a:ext>
                  </a:extLst>
                </a:gridCol>
                <a:gridCol w="525658">
                  <a:extLst>
                    <a:ext uri="{9D8B030D-6E8A-4147-A177-3AD203B41FA5}">
                      <a16:colId xmlns:a16="http://schemas.microsoft.com/office/drawing/2014/main" val="1005501953"/>
                    </a:ext>
                  </a:extLst>
                </a:gridCol>
                <a:gridCol w="634356">
                  <a:extLst>
                    <a:ext uri="{9D8B030D-6E8A-4147-A177-3AD203B41FA5}">
                      <a16:colId xmlns:a16="http://schemas.microsoft.com/office/drawing/2014/main" val="986996313"/>
                    </a:ext>
                  </a:extLst>
                </a:gridCol>
                <a:gridCol w="557547">
                  <a:extLst>
                    <a:ext uri="{9D8B030D-6E8A-4147-A177-3AD203B41FA5}">
                      <a16:colId xmlns:a16="http://schemas.microsoft.com/office/drawing/2014/main" val="2583478591"/>
                    </a:ext>
                  </a:extLst>
                </a:gridCol>
              </a:tblGrid>
              <a:tr h="124814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AB</a:t>
                      </a:r>
                      <a:endParaRPr lang="en-US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37033" marR="37033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Company</a:t>
                      </a:r>
                      <a:endParaRPr lang="en-US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37033" marR="37033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Catalog#</a:t>
                      </a:r>
                      <a:endParaRPr lang="en-US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37033" marR="37033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Western </a:t>
                      </a:r>
                      <a:endParaRPr lang="en-US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37033" marR="37033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IHC</a:t>
                      </a:r>
                      <a:endParaRPr lang="en-US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37033" marR="37033" marT="0" marB="0"/>
                </a:tc>
                <a:extLst>
                  <a:ext uri="{0D108BD9-81ED-4DB2-BD59-A6C34878D82A}">
                    <a16:rowId xmlns:a16="http://schemas.microsoft.com/office/drawing/2014/main" val="1954891658"/>
                  </a:ext>
                </a:extLst>
              </a:tr>
              <a:tr h="330894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ALDH</a:t>
                      </a:r>
                      <a:endParaRPr lang="en-US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37033" marR="37033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Santacruz</a:t>
                      </a:r>
                      <a:endParaRPr lang="en-US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37033" marR="37033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SC-166362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(H-8)</a:t>
                      </a:r>
                      <a:endParaRPr lang="en-US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37033" marR="37033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1:2000 in 5% milk</a:t>
                      </a:r>
                      <a:endParaRPr lang="en-US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37033" marR="37033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1:200</a:t>
                      </a:r>
                      <a:endParaRPr lang="en-US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37033" marR="37033" marT="0" marB="0"/>
                </a:tc>
                <a:extLst>
                  <a:ext uri="{0D108BD9-81ED-4DB2-BD59-A6C34878D82A}">
                    <a16:rowId xmlns:a16="http://schemas.microsoft.com/office/drawing/2014/main" val="2571085958"/>
                  </a:ext>
                </a:extLst>
              </a:tr>
              <a:tr h="330894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CD44</a:t>
                      </a:r>
                      <a:endParaRPr lang="en-US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37033" marR="37033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Abcam</a:t>
                      </a:r>
                      <a:endParaRPr lang="en-US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37033" marR="37033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AB119348 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 </a:t>
                      </a:r>
                      <a:endParaRPr lang="en-US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37033" marR="37033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 </a:t>
                      </a:r>
                      <a:endParaRPr lang="en-US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37033" marR="37033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1:100</a:t>
                      </a:r>
                      <a:endParaRPr lang="en-US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37033" marR="37033" marT="0" marB="0"/>
                </a:tc>
                <a:extLst>
                  <a:ext uri="{0D108BD9-81ED-4DB2-BD59-A6C34878D82A}">
                    <a16:rowId xmlns:a16="http://schemas.microsoft.com/office/drawing/2014/main" val="3442291731"/>
                  </a:ext>
                </a:extLst>
              </a:tr>
              <a:tr h="330894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DKK3</a:t>
                      </a:r>
                      <a:endParaRPr lang="en-US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37033" marR="37033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Invitrogen</a:t>
                      </a:r>
                      <a:endParaRPr lang="en-US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37033" marR="37033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PA5-21325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 </a:t>
                      </a:r>
                      <a:endParaRPr lang="en-US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37033" marR="37033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1:500 in 2.5% BSA</a:t>
                      </a:r>
                      <a:endParaRPr lang="en-US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37033" marR="37033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1:100</a:t>
                      </a:r>
                      <a:endParaRPr lang="en-US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37033" marR="37033" marT="0" marB="0"/>
                </a:tc>
                <a:extLst>
                  <a:ext uri="{0D108BD9-81ED-4DB2-BD59-A6C34878D82A}">
                    <a16:rowId xmlns:a16="http://schemas.microsoft.com/office/drawing/2014/main" val="4227859149"/>
                  </a:ext>
                </a:extLst>
              </a:tr>
              <a:tr h="330894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Dll4</a:t>
                      </a:r>
                      <a:endParaRPr lang="en-US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37033" marR="37033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Santacruz</a:t>
                      </a:r>
                      <a:endParaRPr lang="en-US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37033" marR="37033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SC-28915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 </a:t>
                      </a:r>
                      <a:endParaRPr lang="en-US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37033" marR="37033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1:1000 in 2.5% milk</a:t>
                      </a:r>
                      <a:endParaRPr lang="en-US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37033" marR="37033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1:100</a:t>
                      </a:r>
                      <a:endParaRPr lang="en-US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37033" marR="37033" marT="0" marB="0"/>
                </a:tc>
                <a:extLst>
                  <a:ext uri="{0D108BD9-81ED-4DB2-BD59-A6C34878D82A}">
                    <a16:rowId xmlns:a16="http://schemas.microsoft.com/office/drawing/2014/main" val="257419172"/>
                  </a:ext>
                </a:extLst>
              </a:tr>
              <a:tr h="255800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LGR5</a:t>
                      </a:r>
                      <a:endParaRPr lang="en-US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37033" marR="37033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Abcam</a:t>
                      </a:r>
                      <a:endParaRPr lang="en-US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37033" marR="37033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AB75850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 </a:t>
                      </a:r>
                      <a:endParaRPr lang="en-US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37033" marR="37033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1:500 in 2.5% milk</a:t>
                      </a:r>
                      <a:endParaRPr lang="en-US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37033" marR="37033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1:150</a:t>
                      </a:r>
                      <a:endParaRPr lang="en-US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37033" marR="37033" marT="0" marB="0"/>
                </a:tc>
                <a:extLst>
                  <a:ext uri="{0D108BD9-81ED-4DB2-BD59-A6C34878D82A}">
                    <a16:rowId xmlns:a16="http://schemas.microsoft.com/office/drawing/2014/main" val="2626509791"/>
                  </a:ext>
                </a:extLst>
              </a:tr>
              <a:tr h="330894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WNT4</a:t>
                      </a:r>
                      <a:endParaRPr lang="en-US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37033" marR="37033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Abcam</a:t>
                      </a:r>
                      <a:endParaRPr lang="en-US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37033" marR="37033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SC-13962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 </a:t>
                      </a:r>
                      <a:endParaRPr lang="en-US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37033" marR="37033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1:500 in 2.5% milk</a:t>
                      </a:r>
                      <a:endParaRPr lang="en-US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37033" marR="37033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1:100</a:t>
                      </a:r>
                      <a:endParaRPr lang="en-US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37033" marR="37033" marT="0" marB="0"/>
                </a:tc>
                <a:extLst>
                  <a:ext uri="{0D108BD9-81ED-4DB2-BD59-A6C34878D82A}">
                    <a16:rowId xmlns:a16="http://schemas.microsoft.com/office/drawing/2014/main" val="3319844487"/>
                  </a:ext>
                </a:extLst>
              </a:tr>
              <a:tr h="330894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PAX2</a:t>
                      </a:r>
                      <a:endParaRPr lang="en-US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37033" marR="37033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Invitrogen</a:t>
                      </a:r>
                      <a:endParaRPr lang="en-US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37033" marR="37033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71-6000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 </a:t>
                      </a:r>
                      <a:endParaRPr lang="en-US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37033" marR="37033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1:500 in 2.5% milk</a:t>
                      </a:r>
                      <a:endParaRPr lang="en-US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37033" marR="37033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1:100</a:t>
                      </a:r>
                      <a:endParaRPr lang="en-US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37033" marR="37033" marT="0" marB="0"/>
                </a:tc>
                <a:extLst>
                  <a:ext uri="{0D108BD9-81ED-4DB2-BD59-A6C34878D82A}">
                    <a16:rowId xmlns:a16="http://schemas.microsoft.com/office/drawing/2014/main" val="1156676502"/>
                  </a:ext>
                </a:extLst>
              </a:tr>
              <a:tr h="330894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PTEN</a:t>
                      </a:r>
                      <a:endParaRPr lang="en-US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37033" marR="37033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Cell Signaling</a:t>
                      </a:r>
                      <a:endParaRPr lang="en-US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37033" marR="37033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9188S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 </a:t>
                      </a:r>
                      <a:endParaRPr lang="en-US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37033" marR="37033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1:1000 in 2.5% BSA</a:t>
                      </a:r>
                      <a:endParaRPr lang="en-US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37033" marR="37033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1:50</a:t>
                      </a:r>
                      <a:endParaRPr lang="en-US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37033" marR="37033" marT="0" marB="0"/>
                </a:tc>
                <a:extLst>
                  <a:ext uri="{0D108BD9-81ED-4DB2-BD59-A6C34878D82A}">
                    <a16:rowId xmlns:a16="http://schemas.microsoft.com/office/drawing/2014/main" val="3096323912"/>
                  </a:ext>
                </a:extLst>
              </a:tr>
              <a:tr h="330894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phAKT (Ser473)</a:t>
                      </a:r>
                      <a:endParaRPr lang="en-US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37033" marR="37033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Cell Signaling</a:t>
                      </a:r>
                      <a:endParaRPr lang="en-US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37033" marR="37033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4060S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 </a:t>
                      </a:r>
                      <a:endParaRPr lang="en-US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37033" marR="37033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1:1000 in 5% BSA</a:t>
                      </a:r>
                      <a:endParaRPr lang="en-US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37033" marR="37033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N/A</a:t>
                      </a:r>
                      <a:endParaRPr lang="en-US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37033" marR="37033" marT="0" marB="0"/>
                </a:tc>
                <a:extLst>
                  <a:ext uri="{0D108BD9-81ED-4DB2-BD59-A6C34878D82A}">
                    <a16:rowId xmlns:a16="http://schemas.microsoft.com/office/drawing/2014/main" val="1762970456"/>
                  </a:ext>
                </a:extLst>
              </a:tr>
              <a:tr h="330894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phP706SK (Thr389) (108D2)</a:t>
                      </a:r>
                      <a:endParaRPr lang="en-US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37033" marR="37033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Cell Signaling</a:t>
                      </a:r>
                      <a:endParaRPr lang="en-US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37033" marR="37033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9234S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 </a:t>
                      </a:r>
                      <a:endParaRPr lang="en-US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37033" marR="37033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1:1000 in 5% BSA</a:t>
                      </a:r>
                      <a:endParaRPr lang="en-US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37033" marR="37033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N/A</a:t>
                      </a:r>
                      <a:endParaRPr lang="en-US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37033" marR="37033" marT="0" marB="0"/>
                </a:tc>
                <a:extLst>
                  <a:ext uri="{0D108BD9-81ED-4DB2-BD59-A6C34878D82A}">
                    <a16:rowId xmlns:a16="http://schemas.microsoft.com/office/drawing/2014/main" val="3755028959"/>
                  </a:ext>
                </a:extLst>
              </a:tr>
              <a:tr h="330894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Actin</a:t>
                      </a:r>
                      <a:endParaRPr lang="en-US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37033" marR="37033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Sigma</a:t>
                      </a:r>
                      <a:endParaRPr lang="en-US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37033" marR="37033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A2066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 </a:t>
                      </a:r>
                      <a:endParaRPr lang="en-US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37033" marR="37033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1:1000 in 5% milk</a:t>
                      </a:r>
                      <a:endParaRPr lang="en-US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37033" marR="37033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N/A</a:t>
                      </a:r>
                      <a:endParaRPr lang="en-US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37033" marR="37033" marT="0" marB="0"/>
                </a:tc>
                <a:extLst>
                  <a:ext uri="{0D108BD9-81ED-4DB2-BD59-A6C34878D82A}">
                    <a16:rowId xmlns:a16="http://schemas.microsoft.com/office/drawing/2014/main" val="324056325"/>
                  </a:ext>
                </a:extLst>
              </a:tr>
              <a:tr h="330894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BrDU</a:t>
                      </a:r>
                      <a:endParaRPr lang="en-US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37033" marR="37033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 </a:t>
                      </a:r>
                      <a:endParaRPr lang="en-US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37033" marR="37033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 </a:t>
                      </a:r>
                      <a:endParaRPr lang="en-US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37033" marR="37033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 </a:t>
                      </a:r>
                      <a:endParaRPr lang="en-US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37033" marR="37033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1:40</a:t>
                      </a:r>
                      <a:endParaRPr lang="en-US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37033" marR="37033" marT="0" marB="0"/>
                </a:tc>
                <a:extLst>
                  <a:ext uri="{0D108BD9-81ED-4DB2-BD59-A6C34878D82A}">
                    <a16:rowId xmlns:a16="http://schemas.microsoft.com/office/drawing/2014/main" val="2723659194"/>
                  </a:ext>
                </a:extLst>
              </a:tr>
              <a:tr h="330894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 </a:t>
                      </a:r>
                      <a:endParaRPr lang="en-US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37033" marR="37033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 </a:t>
                      </a:r>
                      <a:endParaRPr lang="en-US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37033" marR="37033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 </a:t>
                      </a:r>
                      <a:endParaRPr lang="en-US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37033" marR="37033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 </a:t>
                      </a:r>
                      <a:endParaRPr lang="en-US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37033" marR="37033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dirty="0">
                          <a:effectLst/>
                        </a:rPr>
                        <a:t> </a:t>
                      </a:r>
                      <a:endParaRPr lang="en-US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37033" marR="37033" marT="0" marB="0"/>
                </a:tc>
                <a:extLst>
                  <a:ext uri="{0D108BD9-81ED-4DB2-BD59-A6C34878D82A}">
                    <a16:rowId xmlns:a16="http://schemas.microsoft.com/office/drawing/2014/main" val="961336487"/>
                  </a:ext>
                </a:extLst>
              </a:tr>
            </a:tbl>
          </a:graphicData>
        </a:graphic>
      </p:graphicFrame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1D9A9BB9-364A-9E40-AF06-CBA76A4433C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99239670"/>
              </p:ext>
            </p:extLst>
          </p:nvPr>
        </p:nvGraphicFramePr>
        <p:xfrm>
          <a:off x="2032000" y="719666"/>
          <a:ext cx="8128000" cy="5435600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1625600">
                  <a:extLst>
                    <a:ext uri="{9D8B030D-6E8A-4147-A177-3AD203B41FA5}">
                      <a16:colId xmlns:a16="http://schemas.microsoft.com/office/drawing/2014/main" val="3639558473"/>
                    </a:ext>
                  </a:extLst>
                </a:gridCol>
                <a:gridCol w="1625600">
                  <a:extLst>
                    <a:ext uri="{9D8B030D-6E8A-4147-A177-3AD203B41FA5}">
                      <a16:colId xmlns:a16="http://schemas.microsoft.com/office/drawing/2014/main" val="2487566810"/>
                    </a:ext>
                  </a:extLst>
                </a:gridCol>
                <a:gridCol w="1625600">
                  <a:extLst>
                    <a:ext uri="{9D8B030D-6E8A-4147-A177-3AD203B41FA5}">
                      <a16:colId xmlns:a16="http://schemas.microsoft.com/office/drawing/2014/main" val="1043904634"/>
                    </a:ext>
                  </a:extLst>
                </a:gridCol>
                <a:gridCol w="1625600">
                  <a:extLst>
                    <a:ext uri="{9D8B030D-6E8A-4147-A177-3AD203B41FA5}">
                      <a16:colId xmlns:a16="http://schemas.microsoft.com/office/drawing/2014/main" val="66054324"/>
                    </a:ext>
                  </a:extLst>
                </a:gridCol>
                <a:gridCol w="1625600">
                  <a:extLst>
                    <a:ext uri="{9D8B030D-6E8A-4147-A177-3AD203B41FA5}">
                      <a16:colId xmlns:a16="http://schemas.microsoft.com/office/drawing/2014/main" val="997762531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ntibodies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ompany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atalog#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Western 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IHC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414278338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LDH</a:t>
                      </a:r>
                      <a:endParaRPr lang="en-US" sz="1400" b="1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antacruz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C-166362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H-8)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:2000 in 5% milk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:200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9375035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D44</a:t>
                      </a:r>
                      <a:endParaRPr lang="en-US" sz="1400" b="1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bcam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rgbClr val="333333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B119348 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:100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8256561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DKK3</a:t>
                      </a:r>
                      <a:endParaRPr lang="en-US" sz="1400" b="1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Invitrogen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A5-21325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:500 in 2.5% BSA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:100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86624688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Dll4</a:t>
                      </a:r>
                      <a:endParaRPr lang="en-US" sz="1400" b="1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antacruz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C-28915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:1000 in 2.5% milk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:100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30516117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LGR5</a:t>
                      </a:r>
                      <a:endParaRPr lang="en-US" sz="1400" b="1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bcam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B75850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:500 in 2.5% milk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:150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81063491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WNT4</a:t>
                      </a:r>
                      <a:endParaRPr lang="en-US" sz="1400" b="1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bcam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C-13962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:500 in 2.5% milk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:100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60478257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AX2</a:t>
                      </a:r>
                      <a:endParaRPr lang="en-US" sz="1400" b="1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Invitrogen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71-6000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:500 in 2.5% milk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:100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08502183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TEN</a:t>
                      </a:r>
                      <a:endParaRPr lang="en-US" sz="1400" b="1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ell Signaling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9188S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:1000 in 2.5% BSA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:50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88111841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hAKT (Ser473)</a:t>
                      </a:r>
                      <a:endParaRPr lang="en-US" sz="1400" b="1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ell Signaling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060S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:1000 in 5% BSA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N/A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35518470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hP706SK (Thr389) (108D2)</a:t>
                      </a:r>
                      <a:endParaRPr lang="en-US" sz="1400" b="1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ell Signaling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9234S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:1000 in 5% BSA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N/A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38314548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ctin</a:t>
                      </a:r>
                      <a:endParaRPr lang="en-US" sz="1400" b="1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igma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2066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:1000 in 5% milk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N/A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92540684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1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BrdU</a:t>
                      </a:r>
                      <a:endParaRPr lang="en-US" sz="1400" b="1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Abcam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AB6326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N/A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:40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214503486"/>
                  </a:ext>
                </a:extLst>
              </a:tr>
            </a:tbl>
          </a:graphicData>
        </a:graphic>
      </p:graphicFrame>
      <p:sp>
        <p:nvSpPr>
          <p:cNvPr id="6" name="Rectangle 1">
            <a:extLst>
              <a:ext uri="{FF2B5EF4-FFF2-40B4-BE49-F238E27FC236}">
                <a16:creationId xmlns:a16="http://schemas.microsoft.com/office/drawing/2014/main" id="{C3DE9DAE-2971-9B4A-B289-97CCB87E6133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78350" y="1825625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Table 1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F8BB03E1-3EE3-1842-ABE4-2E5E3A069045}"/>
              </a:ext>
            </a:extLst>
          </p:cNvPr>
          <p:cNvSpPr txBox="1"/>
          <p:nvPr/>
        </p:nvSpPr>
        <p:spPr>
          <a:xfrm>
            <a:off x="211874" y="91543"/>
            <a:ext cx="11165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Table SII</a:t>
            </a:r>
          </a:p>
        </p:txBody>
      </p:sp>
    </p:spTree>
    <p:extLst>
      <p:ext uri="{BB962C8B-B14F-4D97-AF65-F5344CB8AC3E}">
        <p14:creationId xmlns:p14="http://schemas.microsoft.com/office/powerpoint/2010/main" val="37559726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37</TotalTime>
  <Words>288</Words>
  <Application>Microsoft Macintosh PowerPoint</Application>
  <PresentationFormat>Widescreen</PresentationFormat>
  <Paragraphs>15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usso, Angela</dc:creator>
  <cp:lastModifiedBy>Russo, Angela</cp:lastModifiedBy>
  <cp:revision>6</cp:revision>
  <dcterms:created xsi:type="dcterms:W3CDTF">2020-02-11T16:18:42Z</dcterms:created>
  <dcterms:modified xsi:type="dcterms:W3CDTF">2020-07-09T21:08:29Z</dcterms:modified>
</cp:coreProperties>
</file>